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3" r:id="rId2"/>
    <p:sldId id="262" r:id="rId3"/>
    <p:sldId id="261" r:id="rId4"/>
  </p:sldIdLst>
  <p:sldSz cx="121920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40"/>
    <p:restoredTop sz="96327"/>
  </p:normalViewPr>
  <p:slideViewPr>
    <p:cSldViewPr snapToGrid="0">
      <p:cViewPr>
        <p:scale>
          <a:sx n="111" d="100"/>
          <a:sy n="111" d="100"/>
        </p:scale>
        <p:origin x="120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95781"/>
            <a:ext cx="10363200" cy="382016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763261"/>
            <a:ext cx="9144000" cy="264921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362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821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84200"/>
            <a:ext cx="2628900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84200"/>
            <a:ext cx="7734300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008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974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735583"/>
            <a:ext cx="10515600" cy="456437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343143"/>
            <a:ext cx="10515600" cy="24002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64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921000"/>
            <a:ext cx="51816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921000"/>
            <a:ext cx="51816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196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84202"/>
            <a:ext cx="1051560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89861"/>
            <a:ext cx="5157787" cy="131825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008120"/>
            <a:ext cx="5157787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89861"/>
            <a:ext cx="5183188" cy="131825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008120"/>
            <a:ext cx="5183188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385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041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46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1520"/>
            <a:ext cx="3932237" cy="256032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79882"/>
            <a:ext cx="6172200" cy="779780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91840"/>
            <a:ext cx="3932237" cy="609854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719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1520"/>
            <a:ext cx="3932237" cy="256032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79882"/>
            <a:ext cx="6172200" cy="779780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91840"/>
            <a:ext cx="3932237" cy="609854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835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84202"/>
            <a:ext cx="1051560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921000"/>
            <a:ext cx="1051560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170162"/>
            <a:ext cx="27432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8285C-4EC4-F045-8900-68F531FD580E}" type="datetimeFigureOut">
              <a:rPr lang="en-US" smtClean="0"/>
              <a:t>4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170162"/>
            <a:ext cx="41148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170162"/>
            <a:ext cx="27432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E810A-CC05-D640-A813-45B1BE7C1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394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4B33CE0-5F73-A8DE-F497-85E132A49BB4}"/>
              </a:ext>
            </a:extLst>
          </p:cNvPr>
          <p:cNvSpPr txBox="1"/>
          <p:nvPr/>
        </p:nvSpPr>
        <p:spPr>
          <a:xfrm>
            <a:off x="242301" y="1180024"/>
            <a:ext cx="546355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st of flow cytometry antibodies and MHC tetramers used for staining PBMCs with clones, manufacturers and titration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FE72BF5-2A4E-D55A-475A-0ED49F974C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7525926"/>
              </p:ext>
            </p:extLst>
          </p:nvPr>
        </p:nvGraphicFramePr>
        <p:xfrm>
          <a:off x="309118" y="1641689"/>
          <a:ext cx="5118101" cy="1422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9052">
                  <a:extLst>
                    <a:ext uri="{9D8B030D-6E8A-4147-A177-3AD203B41FA5}">
                      <a16:colId xmlns:a16="http://schemas.microsoft.com/office/drawing/2014/main" val="3878339845"/>
                    </a:ext>
                  </a:extLst>
                </a:gridCol>
                <a:gridCol w="827136">
                  <a:extLst>
                    <a:ext uri="{9D8B030D-6E8A-4147-A177-3AD203B41FA5}">
                      <a16:colId xmlns:a16="http://schemas.microsoft.com/office/drawing/2014/main" val="462328647"/>
                    </a:ext>
                  </a:extLst>
                </a:gridCol>
                <a:gridCol w="522902">
                  <a:extLst>
                    <a:ext uri="{9D8B030D-6E8A-4147-A177-3AD203B41FA5}">
                      <a16:colId xmlns:a16="http://schemas.microsoft.com/office/drawing/2014/main" val="957744495"/>
                    </a:ext>
                  </a:extLst>
                </a:gridCol>
                <a:gridCol w="827136">
                  <a:extLst>
                    <a:ext uri="{9D8B030D-6E8A-4147-A177-3AD203B41FA5}">
                      <a16:colId xmlns:a16="http://schemas.microsoft.com/office/drawing/2014/main" val="1456301088"/>
                    </a:ext>
                  </a:extLst>
                </a:gridCol>
                <a:gridCol w="1571875">
                  <a:extLst>
                    <a:ext uri="{9D8B030D-6E8A-4147-A177-3AD203B41FA5}">
                      <a16:colId xmlns:a16="http://schemas.microsoft.com/office/drawing/2014/main" val="384001701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Specificit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Fluoroph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Clo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Dilu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Manufactur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229566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D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E/Cy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500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</a:rPr>
                        <a:t>Biolegen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05094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D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V4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GK1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D Bioscienc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800491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D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PC/Cy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30-F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3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D Bioscienc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95023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D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FI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KT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3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ThermoFisher Scientif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121379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H-2K(b) mLama4 te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E, AP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1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NIH Tetramer C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2218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-A(b) mItgb1 te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E, AP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:1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IH Tetramer Co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668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97437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12A7B8E-25DE-F423-B031-0EBC7ACDBB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458" y="1746870"/>
            <a:ext cx="2120900" cy="32639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C67C36C-8282-E369-7E76-08872681053D}"/>
              </a:ext>
            </a:extLst>
          </p:cNvPr>
          <p:cNvSpPr txBox="1"/>
          <p:nvPr/>
        </p:nvSpPr>
        <p:spPr>
          <a:xfrm>
            <a:off x="121150" y="5010770"/>
            <a:ext cx="1194969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Number of colonies in soft agar after electroporation of SBKP plasmid systems into MEF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Fs were harvested and electroporated with the SBKP plasmids (N=2), mLama4 SBKP plasmids (N=3), or mLama4/mItgb1 SBKP (N=3) plasmids and monitored for colony formation. Colonies were stained and manually counted after 3 weeks of formation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1742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C67C36C-8282-E369-7E76-08872681053D}"/>
              </a:ext>
            </a:extLst>
          </p:cNvPr>
          <p:cNvSpPr txBox="1"/>
          <p:nvPr/>
        </p:nvSpPr>
        <p:spPr>
          <a:xfrm>
            <a:off x="121150" y="3740344"/>
            <a:ext cx="119496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Flow cytometry gating strategy for identifying CD4 and CD8 T cell population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gressively in order, this gating scheme focuses on lymphocytes, singlets, CD45+ live cells, T cells, then CD4 and CD8 T cell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15F6A2C-74AA-272B-AEAC-059C194943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275" y="1726083"/>
            <a:ext cx="1973943" cy="182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40562FE-CBAA-6DFF-334B-C0E80C5746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3255" y="1726083"/>
            <a:ext cx="1949951" cy="1828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18014FA-D369-32DB-6431-38CA446CC7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9243" y="1726083"/>
            <a:ext cx="1949737" cy="1828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8FD5D78-0A9B-CE96-D506-80982B4F8E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15017" y="1726083"/>
            <a:ext cx="1977242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37A05D6-05F8-8730-414D-50CACDA925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28296" y="1726083"/>
            <a:ext cx="1923803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1780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82</TotalTime>
  <Words>198</Words>
  <Application>Microsoft Macintosh PowerPoint</Application>
  <PresentationFormat>Custom</PresentationFormat>
  <Paragraphs>3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on Himes</dc:creator>
  <cp:lastModifiedBy>Jonathon Himes</cp:lastModifiedBy>
  <cp:revision>28</cp:revision>
  <cp:lastPrinted>2023-03-15T13:04:05Z</cp:lastPrinted>
  <dcterms:created xsi:type="dcterms:W3CDTF">2023-03-13T15:06:52Z</dcterms:created>
  <dcterms:modified xsi:type="dcterms:W3CDTF">2023-04-04T12:20:41Z</dcterms:modified>
</cp:coreProperties>
</file>